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13426A-DB40-4A20-BB02-FA898E81FD0D}" v="2" dt="2024-06-18T14:28:36.7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1" d="100"/>
          <a:sy n="71" d="100"/>
        </p:scale>
        <p:origin x="8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1313426A-DB40-4A20-BB02-FA898E81FD0D}"/>
    <pc:docChg chg="undo custSel delSld modSld">
      <pc:chgData name="Laycock, Joseph" userId="c4bfcbf4-3ccc-440e-b317-559baf184f0d" providerId="ADAL" clId="{1313426A-DB40-4A20-BB02-FA898E81FD0D}" dt="2024-06-18T14:29:32.163" v="52" actId="1035"/>
      <pc:docMkLst>
        <pc:docMk/>
      </pc:docMkLst>
      <pc:sldChg chg="addSp delSp modSp mod">
        <pc:chgData name="Laycock, Joseph" userId="c4bfcbf4-3ccc-440e-b317-559baf184f0d" providerId="ADAL" clId="{1313426A-DB40-4A20-BB02-FA898E81FD0D}" dt="2024-06-18T14:29:32.163" v="52" actId="1035"/>
        <pc:sldMkLst>
          <pc:docMk/>
          <pc:sldMk cId="2867428870" sldId="268"/>
        </pc:sldMkLst>
        <pc:spChg chg="del">
          <ac:chgData name="Laycock, Joseph" userId="c4bfcbf4-3ccc-440e-b317-559baf184f0d" providerId="ADAL" clId="{1313426A-DB40-4A20-BB02-FA898E81FD0D}" dt="2024-06-18T14:27:22.172" v="20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9" creationId="{7545F76C-6EAF-4B2D-B219-4661F60D69FF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0" creationId="{97E35CC1-000F-4DF1-BF17-76DBB5651366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1" creationId="{82414252-E226-4E29-B5BB-47F1724D909B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2" creationId="{8B95C47E-19F0-4065-94E0-41483F17906A}"/>
          </ac:spMkLst>
        </pc:spChg>
        <pc:spChg chg="add mod">
          <ac:chgData name="Laycock, Joseph" userId="c4bfcbf4-3ccc-440e-b317-559baf184f0d" providerId="ADAL" clId="{1313426A-DB40-4A20-BB02-FA898E81FD0D}" dt="2024-06-18T14:29:05.814" v="45" actId="20577"/>
          <ac:spMkLst>
            <pc:docMk/>
            <pc:sldMk cId="2867428870" sldId="268"/>
            <ac:spMk id="13" creationId="{E3BD7455-1A8E-4234-ABF4-D24911E98E56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4" creationId="{B91F0159-2B20-4667-B146-94E876F2BAF9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5" creationId="{7321A327-89D7-440D-9B43-39E7BE5797A9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7" creationId="{2234CBCD-EC12-4F8D-A0D2-1A06FB2BC28F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8" creationId="{7BFE6699-F793-4C5F-ACEE-98D79990641E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19" creationId="{B91AE427-00C2-4BE7-9014-45E7BCE5ED60}"/>
          </ac:spMkLst>
        </pc:spChg>
        <pc:spChg chg="mod">
          <ac:chgData name="Laycock, Joseph" userId="c4bfcbf4-3ccc-440e-b317-559baf184f0d" providerId="ADAL" clId="{1313426A-DB40-4A20-BB02-FA898E81FD0D}" dt="2024-06-18T14:26:36.643" v="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1313426A-DB40-4A20-BB02-FA898E81FD0D}" dt="2024-06-18T14:26:48.517" v="11" actId="1038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Laycock, Joseph" userId="c4bfcbf4-3ccc-440e-b317-559baf184f0d" providerId="ADAL" clId="{1313426A-DB40-4A20-BB02-FA898E81FD0D}" dt="2024-06-18T14:26:52.915" v="12" actId="20577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1313426A-DB40-4A20-BB02-FA898E81FD0D}" dt="2024-06-18T14:27:16.619" v="19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1313426A-DB40-4A20-BB02-FA898E81FD0D}" dt="2024-06-18T14:27:07.635" v="18" actId="20577"/>
          <ac:spMkLst>
            <pc:docMk/>
            <pc:sldMk cId="2867428870" sldId="268"/>
            <ac:spMk id="28" creationId="{00000000-0000-0000-0000-000000000000}"/>
          </ac:spMkLst>
        </pc:spChg>
        <pc:spChg chg="add mod">
          <ac:chgData name="Laycock, Joseph" userId="c4bfcbf4-3ccc-440e-b317-559baf184f0d" providerId="ADAL" clId="{1313426A-DB40-4A20-BB02-FA898E81FD0D}" dt="2024-06-18T14:27:55.630" v="25" actId="1037"/>
          <ac:spMkLst>
            <pc:docMk/>
            <pc:sldMk cId="2867428870" sldId="268"/>
            <ac:spMk id="29" creationId="{58B92738-9AF4-4262-A0E7-54F39B964A6E}"/>
          </ac:spMkLst>
        </pc:spChg>
        <pc:spChg chg="add mod">
          <ac:chgData name="Laycock, Joseph" userId="c4bfcbf4-3ccc-440e-b317-559baf184f0d" providerId="ADAL" clId="{1313426A-DB40-4A20-BB02-FA898E81FD0D}" dt="2024-06-18T14:29:18.952" v="46" actId="14100"/>
          <ac:spMkLst>
            <pc:docMk/>
            <pc:sldMk cId="2867428870" sldId="268"/>
            <ac:spMk id="32" creationId="{BBDC6B70-9984-4D74-9DF9-C11E2602D175}"/>
          </ac:spMkLst>
        </pc:spChg>
        <pc:graphicFrameChg chg="add mod">
          <ac:chgData name="Laycock, Joseph" userId="c4bfcbf4-3ccc-440e-b317-559baf184f0d" providerId="ADAL" clId="{1313426A-DB40-4A20-BB02-FA898E81FD0D}" dt="2024-06-18T14:27:55.630" v="25" actId="1037"/>
          <ac:graphicFrameMkLst>
            <pc:docMk/>
            <pc:sldMk cId="2867428870" sldId="268"/>
            <ac:graphicFrameMk id="16" creationId="{7145D036-951B-4CA9-AF31-49CC37CEF181}"/>
          </ac:graphicFrameMkLst>
        </pc:graphicFrameChg>
        <pc:picChg chg="add mod">
          <ac:chgData name="Laycock, Joseph" userId="c4bfcbf4-3ccc-440e-b317-559baf184f0d" providerId="ADAL" clId="{1313426A-DB40-4A20-BB02-FA898E81FD0D}" dt="2024-06-18T14:27:55.630" v="25" actId="1037"/>
          <ac:picMkLst>
            <pc:docMk/>
            <pc:sldMk cId="2867428870" sldId="268"/>
            <ac:picMk id="3" creationId="{C221C1BE-C732-4BB9-A554-4414464AC974}"/>
          </ac:picMkLst>
        </pc:picChg>
        <pc:cxnChg chg="add mod">
          <ac:chgData name="Laycock, Joseph" userId="c4bfcbf4-3ccc-440e-b317-559baf184f0d" providerId="ADAL" clId="{1313426A-DB40-4A20-BB02-FA898E81FD0D}" dt="2024-06-18T14:27:55.630" v="25" actId="1037"/>
          <ac:cxnSpMkLst>
            <pc:docMk/>
            <pc:sldMk cId="2867428870" sldId="268"/>
            <ac:cxnSpMk id="33" creationId="{2E6E8EA1-EB14-4952-A986-43171C8FCB80}"/>
          </ac:cxnSpMkLst>
        </pc:cxnChg>
        <pc:cxnChg chg="add mod">
          <ac:chgData name="Laycock, Joseph" userId="c4bfcbf4-3ccc-440e-b317-559baf184f0d" providerId="ADAL" clId="{1313426A-DB40-4A20-BB02-FA898E81FD0D}" dt="2024-06-18T14:29:32.163" v="52" actId="1035"/>
          <ac:cxnSpMkLst>
            <pc:docMk/>
            <pc:sldMk cId="2867428870" sldId="268"/>
            <ac:cxnSpMk id="34" creationId="{BF14CFCA-24A4-4A81-AB10-56B367105B81}"/>
          </ac:cxnSpMkLst>
        </pc:cxnChg>
      </pc:sldChg>
      <pc:sldChg chg="del">
        <pc:chgData name="Laycock, Joseph" userId="c4bfcbf4-3ccc-440e-b317-559baf184f0d" providerId="ADAL" clId="{1313426A-DB40-4A20-BB02-FA898E81FD0D}" dt="2024-06-18T14:26:14.170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1313426A-DB40-4A20-BB02-FA898E81FD0D}" dt="2024-06-18T14:26:16.519" v="4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1313426A-DB40-4A20-BB02-FA898E81FD0D}" dt="2024-06-18T14:26:16.941" v="5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1313426A-DB40-4A20-BB02-FA898E81FD0D}" dt="2024-06-18T14:26:15.448" v="1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1313426A-DB40-4A20-BB02-FA898E81FD0D}" dt="2024-06-18T14:26:15.850" v="2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1313426A-DB40-4A20-BB02-FA898E81FD0D}" dt="2024-06-18T14:26:16.203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1313426A-DB40-4A20-BB02-FA898E81FD0D}" dt="2024-06-18T14:26:16.941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1313426A-DB40-4A20-BB02-FA898E81FD0D}" dt="2024-06-18T14:26:16.941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Quality of life in children at different stages of chronic kidney disease in a developing countr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3215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Quality of life in children with CKD is associated with clinical and socioeconomic factors. </a:t>
            </a:r>
            <a:r>
              <a:rPr lang="en-GB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Chaichan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KD stage 5D patients and patients with low maternal education had lower QoL. Regular QoL assessment is recommended for advanced CKD patients and patients with socioeconomic vulnerabilities.</a:t>
            </a: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7545F76C-6EAF-4B2D-B219-4661F60D69FF}"/>
              </a:ext>
            </a:extLst>
          </p:cNvPr>
          <p:cNvSpPr/>
          <p:nvPr/>
        </p:nvSpPr>
        <p:spPr>
          <a:xfrm>
            <a:off x="194964" y="383807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97E35CC1-000F-4DF1-BF17-76DBB5651366}"/>
              </a:ext>
            </a:extLst>
          </p:cNvPr>
          <p:cNvSpPr/>
          <p:nvPr/>
        </p:nvSpPr>
        <p:spPr>
          <a:xfrm>
            <a:off x="618070" y="383807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82414252-E226-4E29-B5BB-47F1724D909B}"/>
              </a:ext>
            </a:extLst>
          </p:cNvPr>
          <p:cNvSpPr/>
          <p:nvPr/>
        </p:nvSpPr>
        <p:spPr>
          <a:xfrm>
            <a:off x="1117509" y="384657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8B95C47E-19F0-4065-94E0-41483F17906A}"/>
              </a:ext>
            </a:extLst>
          </p:cNvPr>
          <p:cNvSpPr/>
          <p:nvPr/>
        </p:nvSpPr>
        <p:spPr>
          <a:xfrm>
            <a:off x="1616948" y="384657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3BD7455-1A8E-4234-ABF4-D24911E98E56}"/>
              </a:ext>
            </a:extLst>
          </p:cNvPr>
          <p:cNvSpPr/>
          <p:nvPr/>
        </p:nvSpPr>
        <p:spPr>
          <a:xfrm>
            <a:off x="64011" y="2462479"/>
            <a:ext cx="2675659" cy="1049897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dirty="0">
              <a:solidFill>
                <a:srgbClr val="296DC0"/>
              </a:solidFill>
            </a:endParaRPr>
          </a:p>
          <a:p>
            <a:r>
              <a:rPr lang="en-GB" dirty="0">
                <a:solidFill>
                  <a:schemeClr val="tx1"/>
                </a:solidFill>
              </a:rPr>
              <a:t>87 children with CKD:</a:t>
            </a:r>
          </a:p>
          <a:p>
            <a:r>
              <a:rPr lang="en-GB" dirty="0">
                <a:solidFill>
                  <a:schemeClr val="tx1"/>
                </a:solidFill>
              </a:rPr>
              <a:t>Stage 2–3: n = 29</a:t>
            </a:r>
          </a:p>
          <a:p>
            <a:r>
              <a:rPr lang="en-GB" dirty="0">
                <a:solidFill>
                  <a:schemeClr val="tx1"/>
                </a:solidFill>
              </a:rPr>
              <a:t>Stage 4–5: n = 19</a:t>
            </a:r>
          </a:p>
          <a:p>
            <a:r>
              <a:rPr lang="en-GB" dirty="0">
                <a:solidFill>
                  <a:schemeClr val="tx1"/>
                </a:solidFill>
              </a:rPr>
              <a:t>Stage 5D: n = 20</a:t>
            </a:r>
          </a:p>
          <a:p>
            <a:r>
              <a:rPr lang="en-GB" dirty="0">
                <a:solidFill>
                  <a:schemeClr val="tx1"/>
                </a:solidFill>
              </a:rPr>
              <a:t>KT: n = 19</a:t>
            </a:r>
          </a:p>
          <a:p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91F0159-2B20-4667-B146-94E876F2BAF9}"/>
              </a:ext>
            </a:extLst>
          </p:cNvPr>
          <p:cNvSpPr/>
          <p:nvPr/>
        </p:nvSpPr>
        <p:spPr>
          <a:xfrm>
            <a:off x="64011" y="4973146"/>
            <a:ext cx="2329222" cy="62284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Cross-sectional stud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321A327-89D7-440D-9B43-39E7BE5797A9}"/>
              </a:ext>
            </a:extLst>
          </p:cNvPr>
          <p:cNvSpPr/>
          <p:nvPr/>
        </p:nvSpPr>
        <p:spPr>
          <a:xfrm>
            <a:off x="2702290" y="2332151"/>
            <a:ext cx="2035688" cy="894599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00437A"/>
                </a:solidFill>
              </a:rPr>
              <a:t>Thai version of the </a:t>
            </a:r>
            <a:r>
              <a:rPr lang="en-GB" dirty="0" err="1">
                <a:solidFill>
                  <a:srgbClr val="00437A"/>
                </a:solidFill>
              </a:rPr>
              <a:t>PedsQLTM</a:t>
            </a:r>
            <a:r>
              <a:rPr lang="en-GB" dirty="0">
                <a:solidFill>
                  <a:srgbClr val="00437A"/>
                </a:solidFill>
              </a:rPr>
              <a:t> 4.0 Generic Core Scal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221C1BE-C732-4BB9-A554-4414464AC9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4378" y="2654472"/>
            <a:ext cx="847417" cy="249958"/>
          </a:xfrm>
          <a:prstGeom prst="rect">
            <a:avLst/>
          </a:prstGeom>
        </p:spPr>
      </p:pic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7145D036-951B-4CA9-AF31-49CC37CEF1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6381608"/>
              </p:ext>
            </p:extLst>
          </p:nvPr>
        </p:nvGraphicFramePr>
        <p:xfrm>
          <a:off x="5575454" y="2468874"/>
          <a:ext cx="6595555" cy="2300510"/>
        </p:xfrm>
        <a:graphic>
          <a:graphicData uri="http://schemas.openxmlformats.org/drawingml/2006/table">
            <a:tbl>
              <a:tblPr firstRow="1" firstCol="1" bandRow="1"/>
              <a:tblGrid>
                <a:gridCol w="2134322">
                  <a:extLst>
                    <a:ext uri="{9D8B030D-6E8A-4147-A177-3AD203B41FA5}">
                      <a16:colId xmlns:a16="http://schemas.microsoft.com/office/drawing/2014/main" val="1337343878"/>
                    </a:ext>
                  </a:extLst>
                </a:gridCol>
                <a:gridCol w="1341536">
                  <a:extLst>
                    <a:ext uri="{9D8B030D-6E8A-4147-A177-3AD203B41FA5}">
                      <a16:colId xmlns:a16="http://schemas.microsoft.com/office/drawing/2014/main" val="3237303053"/>
                    </a:ext>
                  </a:extLst>
                </a:gridCol>
                <a:gridCol w="912824">
                  <a:extLst>
                    <a:ext uri="{9D8B030D-6E8A-4147-A177-3AD203B41FA5}">
                      <a16:colId xmlns:a16="http://schemas.microsoft.com/office/drawing/2014/main" val="3570899081"/>
                    </a:ext>
                  </a:extLst>
                </a:gridCol>
                <a:gridCol w="1312516">
                  <a:extLst>
                    <a:ext uri="{9D8B030D-6E8A-4147-A177-3AD203B41FA5}">
                      <a16:colId xmlns:a16="http://schemas.microsoft.com/office/drawing/2014/main" val="3559955171"/>
                    </a:ext>
                  </a:extLst>
                </a:gridCol>
                <a:gridCol w="894357">
                  <a:extLst>
                    <a:ext uri="{9D8B030D-6E8A-4147-A177-3AD203B41FA5}">
                      <a16:colId xmlns:a16="http://schemas.microsoft.com/office/drawing/2014/main" val="2928862949"/>
                    </a:ext>
                  </a:extLst>
                </a:gridCol>
              </a:tblGrid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Characteristic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Parent-report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6951436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Univariate linear regression analysi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Multivariate linear regression analysi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3763658"/>
                  </a:ext>
                </a:extLst>
              </a:tr>
              <a:tr h="28756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β (unstandardized coefficients)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P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β (unstandardized coefficients)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P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6858043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CKD stage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4473139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 marL="11430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CKD stage 4–5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1.59 (−6.38, 9.57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69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3.64 (−13.98, 6.70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49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0818873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 marL="11430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CKD stage 5D</a:t>
                      </a:r>
                      <a:r>
                        <a:rPr lang="en-US" sz="800" b="1" kern="0" baseline="3000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a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8.3 (−15.93, −0.67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3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15.92 (−29.42, −2.43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2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9495131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Kidney transplant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1.29 (−6.68, 9.28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75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10.89 (−23.42, 1.64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9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4646039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Height &lt; 3</a:t>
                      </a:r>
                      <a:r>
                        <a:rPr lang="en-US" sz="800" b="1" kern="0" baseline="3000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rd</a:t>
                      </a: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 percentile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15 (−0.09, 0.39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21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8.14 (−0.90, 17.17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8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2962537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Anemia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4.90 (−11.46, 1.67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14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3.00 (−11.18, 5.19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47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1476597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Number of medication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2.06 (−0.86, 0.45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53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77 (−0.25, 1.78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14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106475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Children who left schoo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0.90 (−12.31, 10.52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8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2.26 (−9.85, 14.38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71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446827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Not living with parent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11.30 (−11.68, 5.37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46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8.94 (−31.47, 13.59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43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96058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Family income (&lt; 10,000 THB)</a:t>
                      </a:r>
                      <a:r>
                        <a:rPr lang="en-US" sz="800" b="1" kern="0" baseline="3000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b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38 (−9.55, 10.30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94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9.79 (−21.10, 1.51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9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358997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Maternal education level: high school or les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8.19 (−15.29, −1.08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2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10.13 (−19.66, −0.60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04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9991403"/>
                  </a:ext>
                </a:extLst>
              </a:tr>
              <a:tr h="14378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206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Paternal education level: high school or less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−4.02 (−12.49, 4.46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35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1.61 (−9.31, 12.53)</a:t>
                      </a:r>
                      <a:endParaRPr lang="en-US" sz="110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kern="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ngsana New" panose="02020603050405020304" pitchFamily="18" charset="-34"/>
                        </a:rPr>
                        <a:t>0.7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ngsana New" panose="02020603050405020304" pitchFamily="18" charset="-34"/>
                      </a:endParaRPr>
                    </a:p>
                  </a:txBody>
                  <a:tcPr marL="18415" marR="1841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249903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2234CBCD-EC12-4F8D-A0D2-1A06FB2BC28F}"/>
              </a:ext>
            </a:extLst>
          </p:cNvPr>
          <p:cNvSpPr txBox="1"/>
          <p:nvPr/>
        </p:nvSpPr>
        <p:spPr>
          <a:xfrm>
            <a:off x="6888407" y="1951680"/>
            <a:ext cx="387638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004277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ltivariable linear regression analyses of the relationships </a:t>
            </a:r>
          </a:p>
          <a:p>
            <a:r>
              <a:rPr lang="en-US" sz="1100" b="1" dirty="0">
                <a:solidFill>
                  <a:srgbClr val="004277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tween different factors and parent-reported </a:t>
            </a:r>
            <a:r>
              <a:rPr lang="en-US" sz="1100" b="1" dirty="0" err="1">
                <a:solidFill>
                  <a:srgbClr val="004277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dsQL</a:t>
            </a:r>
            <a:r>
              <a:rPr lang="en-US" sz="1100" b="1" dirty="0">
                <a:solidFill>
                  <a:srgbClr val="004277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core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FE6699-F793-4C5F-ACEE-98D79990641E}"/>
              </a:ext>
            </a:extLst>
          </p:cNvPr>
          <p:cNvSpPr txBox="1"/>
          <p:nvPr/>
        </p:nvSpPr>
        <p:spPr>
          <a:xfrm>
            <a:off x="5653388" y="4889390"/>
            <a:ext cx="48993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THB: Thai baht</a:t>
            </a:r>
          </a:p>
          <a:p>
            <a:r>
              <a:rPr lang="en-US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luding peritoneal dialysis and hemodialysis.</a:t>
            </a:r>
          </a:p>
          <a:p>
            <a:r>
              <a:rPr lang="en-US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,000 THB is equal to approximately 290 United States dollars (USD).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91AE427-00C2-4BE7-9014-45E7BCE5ED60}"/>
              </a:ext>
            </a:extLst>
          </p:cNvPr>
          <p:cNvSpPr/>
          <p:nvPr/>
        </p:nvSpPr>
        <p:spPr>
          <a:xfrm>
            <a:off x="5653388" y="3319622"/>
            <a:ext cx="5907234" cy="14547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8B92738-9AF4-4262-A0E7-54F39B964A6E}"/>
              </a:ext>
            </a:extLst>
          </p:cNvPr>
          <p:cNvSpPr/>
          <p:nvPr/>
        </p:nvSpPr>
        <p:spPr>
          <a:xfrm>
            <a:off x="5576962" y="4470301"/>
            <a:ext cx="5947289" cy="14547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BBDC6B70-9984-4D74-9DF9-C11E2602D175}"/>
              </a:ext>
            </a:extLst>
          </p:cNvPr>
          <p:cNvSpPr/>
          <p:nvPr/>
        </p:nvSpPr>
        <p:spPr>
          <a:xfrm>
            <a:off x="2650882" y="3948507"/>
            <a:ext cx="2847109" cy="151144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AA0065"/>
                </a:solidFill>
              </a:rPr>
              <a:t>Parent-reported scores: weak-to-moderate correlation with self-reported scores </a:t>
            </a:r>
          </a:p>
          <a:p>
            <a:r>
              <a:rPr lang="en-GB" dirty="0">
                <a:solidFill>
                  <a:srgbClr val="AA0065"/>
                </a:solidFill>
              </a:rPr>
              <a:t>(</a:t>
            </a:r>
            <a:r>
              <a:rPr lang="en-GB" i="1" dirty="0">
                <a:solidFill>
                  <a:srgbClr val="AA0065"/>
                </a:solidFill>
              </a:rPr>
              <a:t>r </a:t>
            </a:r>
            <a:r>
              <a:rPr lang="en-GB" dirty="0">
                <a:solidFill>
                  <a:srgbClr val="AA0065"/>
                </a:solidFill>
              </a:rPr>
              <a:t>= 0.12 – 0.42)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E6E8EA1-EB14-4952-A986-43171C8FCB80}"/>
              </a:ext>
            </a:extLst>
          </p:cNvPr>
          <p:cNvCxnSpPr>
            <a:cxnSpLocks/>
          </p:cNvCxnSpPr>
          <p:nvPr/>
        </p:nvCxnSpPr>
        <p:spPr>
          <a:xfrm>
            <a:off x="4792083" y="2850040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BF14CFCA-24A4-4A81-AB10-56B367105B81}"/>
              </a:ext>
            </a:extLst>
          </p:cNvPr>
          <p:cNvCxnSpPr>
            <a:cxnSpLocks/>
          </p:cNvCxnSpPr>
          <p:nvPr/>
        </p:nvCxnSpPr>
        <p:spPr>
          <a:xfrm>
            <a:off x="3694841" y="3326801"/>
            <a:ext cx="0" cy="56337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7</TotalTime>
  <Words>449</Words>
  <Application>Microsoft Office PowerPoint</Application>
  <PresentationFormat>Widescreen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6-18T14:29:33Z</dcterms:modified>
</cp:coreProperties>
</file>